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ACDCFA-BDE7-4FB2-9694-E78F68C521D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CAE5A8-7481-4384-8204-E54F39C68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297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amples</a:t>
            </a:r>
            <a:r>
              <a:rPr lang="en-US" baseline="0" dirty="0" smtClean="0"/>
              <a:t> details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CAE5A8-7481-4384-8204-E54F39C682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914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20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580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520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53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258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097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55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243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769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678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8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96C6F-A21A-44B2-B1F8-64F33D52A35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15CE2-2610-4483-84FF-0F841CEE9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88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8.jpeg"/><Relationship Id="rId18" Type="http://schemas.openxmlformats.org/officeDocument/2006/relationships/image" Target="../media/image12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jpeg"/><Relationship Id="rId12" Type="http://schemas.openxmlformats.org/officeDocument/2006/relationships/image" Target="../media/image7.png"/><Relationship Id="rId17" Type="http://schemas.microsoft.com/office/2007/relationships/hdphoto" Target="../media/hdphoto1.wdp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jpeg"/><Relationship Id="rId11" Type="http://schemas.openxmlformats.org/officeDocument/2006/relationships/image" Target="../media/image6.jpeg"/><Relationship Id="rId5" Type="http://schemas.openxmlformats.org/officeDocument/2006/relationships/image" Target="../media/image1.emf"/><Relationship Id="rId15" Type="http://schemas.openxmlformats.org/officeDocument/2006/relationships/image" Target="../media/image10.png"/><Relationship Id="rId10" Type="http://schemas.openxmlformats.org/officeDocument/2006/relationships/image" Target="../media/image2.emf"/><Relationship Id="rId19" Type="http://schemas.openxmlformats.org/officeDocument/2006/relationships/image" Target="../media/image13.jpeg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2.bin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5" name="Group 94"/>
          <p:cNvGrpSpPr/>
          <p:nvPr/>
        </p:nvGrpSpPr>
        <p:grpSpPr>
          <a:xfrm>
            <a:off x="279396" y="939984"/>
            <a:ext cx="11780842" cy="5377688"/>
            <a:chOff x="279396" y="962844"/>
            <a:chExt cx="11780842" cy="5377688"/>
          </a:xfrm>
        </p:grpSpPr>
        <p:grpSp>
          <p:nvGrpSpPr>
            <p:cNvPr id="69" name="Group 68"/>
            <p:cNvGrpSpPr/>
            <p:nvPr/>
          </p:nvGrpSpPr>
          <p:grpSpPr>
            <a:xfrm>
              <a:off x="5295624" y="969125"/>
              <a:ext cx="6764614" cy="5371407"/>
              <a:chOff x="96405" y="874633"/>
              <a:chExt cx="6764614" cy="5371407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180819" y="1072378"/>
                <a:ext cx="6680200" cy="5173662"/>
                <a:chOff x="1122238" y="980303"/>
                <a:chExt cx="6712249" cy="5173662"/>
              </a:xfrm>
            </p:grpSpPr>
            <p:graphicFrame>
              <p:nvGraphicFramePr>
                <p:cNvPr id="14" name="Object 1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44113511"/>
                    </p:ext>
                  </p:extLst>
                </p:nvPr>
              </p:nvGraphicFramePr>
              <p:xfrm>
                <a:off x="1122238" y="980303"/>
                <a:ext cx="6712249" cy="51736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96" name="Worksheet" r:id="rId4" imgW="6713079" imgH="5173900" progId="Excel.Sheet.12">
                        <p:embed/>
                      </p:oleObj>
                    </mc:Choice>
                    <mc:Fallback>
                      <p:oleObj name="Worksheet" r:id="rId4" imgW="6713079" imgH="5173900" progId="Excel.Sheet.12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122238" y="980303"/>
                              <a:ext cx="6712249" cy="517366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-2060" b="12151"/>
                <a:stretch/>
              </p:blipFill>
              <p:spPr>
                <a:xfrm>
                  <a:off x="3206549" y="3577511"/>
                  <a:ext cx="1597894" cy="2443626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0403" b="888"/>
                <a:stretch/>
              </p:blipFill>
              <p:spPr>
                <a:xfrm>
                  <a:off x="5378536" y="3308798"/>
                  <a:ext cx="1807846" cy="1846727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537" t="13753"/>
                <a:stretch/>
              </p:blipFill>
              <p:spPr>
                <a:xfrm>
                  <a:off x="3306618" y="1470156"/>
                  <a:ext cx="1422400" cy="2011950"/>
                </a:xfrm>
                <a:prstGeom prst="rect">
                  <a:avLst/>
                </a:prstGeom>
              </p:spPr>
            </p:pic>
          </p:grpSp>
          <p:sp>
            <p:nvSpPr>
              <p:cNvPr id="64" name="TextBox 63"/>
              <p:cNvSpPr txBox="1"/>
              <p:nvPr/>
            </p:nvSpPr>
            <p:spPr>
              <a:xfrm>
                <a:off x="96405" y="874633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93" name="Group 92"/>
            <p:cNvGrpSpPr/>
            <p:nvPr/>
          </p:nvGrpSpPr>
          <p:grpSpPr>
            <a:xfrm>
              <a:off x="279396" y="962844"/>
              <a:ext cx="5097467" cy="5354285"/>
              <a:chOff x="7058184" y="821638"/>
              <a:chExt cx="5097467" cy="5354285"/>
            </a:xfrm>
          </p:grpSpPr>
          <p:grpSp>
            <p:nvGrpSpPr>
              <p:cNvPr id="68" name="Group 67"/>
              <p:cNvGrpSpPr/>
              <p:nvPr/>
            </p:nvGrpSpPr>
            <p:grpSpPr>
              <a:xfrm>
                <a:off x="7058184" y="821638"/>
                <a:ext cx="5097467" cy="2693804"/>
                <a:chOff x="7159626" y="837426"/>
                <a:chExt cx="5097467" cy="2693804"/>
              </a:xfrm>
            </p:grpSpPr>
            <p:grpSp>
              <p:nvGrpSpPr>
                <p:cNvPr id="23" name="Group 22"/>
                <p:cNvGrpSpPr/>
                <p:nvPr/>
              </p:nvGrpSpPr>
              <p:grpSpPr>
                <a:xfrm>
                  <a:off x="7372355" y="1046792"/>
                  <a:ext cx="4884738" cy="2484438"/>
                  <a:chOff x="7372355" y="1061743"/>
                  <a:chExt cx="4884738" cy="2484438"/>
                </a:xfrm>
              </p:grpSpPr>
              <p:graphicFrame>
                <p:nvGraphicFramePr>
                  <p:cNvPr id="19" name="Object 18"/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803266116"/>
                      </p:ext>
                    </p:extLst>
                  </p:nvPr>
                </p:nvGraphicFramePr>
                <p:xfrm>
                  <a:off x="7372355" y="1061743"/>
                  <a:ext cx="4884738" cy="2484438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1097" name="Worksheet" r:id="rId9" imgW="4884279" imgH="2484234" progId="Excel.Sheet.12">
                          <p:embed/>
                        </p:oleObj>
                      </mc:Choice>
                      <mc:Fallback>
                        <p:oleObj name="Worksheet" r:id="rId9" imgW="4884279" imgH="2484234" progId="Excel.Sheet.12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10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7372355" y="1061743"/>
                                <a:ext cx="4884738" cy="2484438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pic>
                <p:nvPicPr>
                  <p:cNvPr id="22" name="Picture 21"/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106830" y="1546257"/>
                    <a:ext cx="2669482" cy="177965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65" name="TextBox 64"/>
                <p:cNvSpPr txBox="1"/>
                <p:nvPr/>
              </p:nvSpPr>
              <p:spPr>
                <a:xfrm>
                  <a:off x="7159626" y="837426"/>
                  <a:ext cx="29527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1" name="Group 90"/>
              <p:cNvGrpSpPr/>
              <p:nvPr/>
            </p:nvGrpSpPr>
            <p:grpSpPr>
              <a:xfrm>
                <a:off x="7214801" y="3363813"/>
                <a:ext cx="4830037" cy="2812110"/>
                <a:chOff x="7214801" y="3363813"/>
                <a:chExt cx="4830037" cy="2812110"/>
              </a:xfrm>
            </p:grpSpPr>
            <p:grpSp>
              <p:nvGrpSpPr>
                <p:cNvPr id="86" name="Group 85"/>
                <p:cNvGrpSpPr/>
                <p:nvPr/>
              </p:nvGrpSpPr>
              <p:grpSpPr>
                <a:xfrm>
                  <a:off x="7214801" y="3363813"/>
                  <a:ext cx="4830037" cy="2812110"/>
                  <a:chOff x="7361963" y="3311049"/>
                  <a:chExt cx="4830037" cy="2812110"/>
                </a:xfrm>
              </p:grpSpPr>
              <p:grpSp>
                <p:nvGrpSpPr>
                  <p:cNvPr id="72" name="Group 71"/>
                  <p:cNvGrpSpPr/>
                  <p:nvPr/>
                </p:nvGrpSpPr>
                <p:grpSpPr>
                  <a:xfrm>
                    <a:off x="7361963" y="3311049"/>
                    <a:ext cx="4830037" cy="2812110"/>
                    <a:chOff x="7361963" y="3311049"/>
                    <a:chExt cx="4830037" cy="2812110"/>
                  </a:xfrm>
                </p:grpSpPr>
                <p:grpSp>
                  <p:nvGrpSpPr>
                    <p:cNvPr id="45" name="Group 44"/>
                    <p:cNvGrpSpPr/>
                    <p:nvPr/>
                  </p:nvGrpSpPr>
                  <p:grpSpPr>
                    <a:xfrm>
                      <a:off x="9132880" y="5340456"/>
                      <a:ext cx="173185" cy="690587"/>
                      <a:chOff x="9377453" y="4345323"/>
                      <a:chExt cx="173185" cy="690587"/>
                    </a:xfrm>
                  </p:grpSpPr>
                  <p:sp>
                    <p:nvSpPr>
                      <p:cNvPr id="46" name="Flowchart: Delay 45"/>
                      <p:cNvSpPr/>
                      <p:nvPr/>
                    </p:nvSpPr>
                    <p:spPr>
                      <a:xfrm rot="5400000" flipV="1">
                        <a:off x="9226569" y="4719461"/>
                        <a:ext cx="472099" cy="160799"/>
                      </a:xfrm>
                      <a:prstGeom prst="flowChartDelay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7" name="Flowchart: Sequential Access Storage 46"/>
                      <p:cNvSpPr/>
                      <p:nvPr/>
                    </p:nvSpPr>
                    <p:spPr>
                      <a:xfrm rot="12507589">
                        <a:off x="9409013" y="4841068"/>
                        <a:ext cx="99989" cy="105506"/>
                      </a:xfrm>
                      <a:prstGeom prst="flowChartMagneticTape">
                        <a:avLst/>
                      </a:prstGeom>
                      <a:gradFill flip="none" rotWithShape="1">
                        <a:gsLst>
                          <a:gs pos="0">
                            <a:srgbClr val="FF66CC">
                              <a:tint val="66000"/>
                              <a:satMod val="160000"/>
                            </a:srgbClr>
                          </a:gs>
                          <a:gs pos="50000">
                            <a:srgbClr val="FF66CC">
                              <a:tint val="44500"/>
                              <a:satMod val="160000"/>
                            </a:srgbClr>
                          </a:gs>
                          <a:gs pos="100000">
                            <a:srgbClr val="FF66CC">
                              <a:tint val="23500"/>
                              <a:satMod val="160000"/>
                            </a:srgbClr>
                          </a:gs>
                        </a:gsLst>
                        <a:lin ang="5400000" scaled="1"/>
                        <a:tileRect/>
                      </a:gradFill>
                      <a:ln>
                        <a:solidFill>
                          <a:srgbClr val="FF66CC">
                            <a:alpha val="14902"/>
                          </a:srgb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8" name="Flowchart: Direct Access Storage 47"/>
                      <p:cNvSpPr/>
                      <p:nvPr/>
                    </p:nvSpPr>
                    <p:spPr>
                      <a:xfrm rot="5400000">
                        <a:off x="9339045" y="4383731"/>
                        <a:ext cx="250002" cy="173185"/>
                      </a:xfrm>
                      <a:prstGeom prst="flowChartMagneticDrum">
                        <a:avLst/>
                      </a:prstGeom>
                      <a:solidFill>
                        <a:schemeClr val="accent5">
                          <a:lumMod val="75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grpSp>
                  <p:nvGrpSpPr>
                    <p:cNvPr id="67" name="Group 66"/>
                    <p:cNvGrpSpPr/>
                    <p:nvPr/>
                  </p:nvGrpSpPr>
                  <p:grpSpPr>
                    <a:xfrm>
                      <a:off x="7361963" y="3311049"/>
                      <a:ext cx="4830037" cy="2812110"/>
                      <a:chOff x="7361963" y="3311049"/>
                      <a:chExt cx="4830037" cy="2812110"/>
                    </a:xfrm>
                  </p:grpSpPr>
                  <p:pic>
                    <p:nvPicPr>
                      <p:cNvPr id="26" name="Picture 25"/>
                      <p:cNvPicPr>
                        <a:picLocks noChangeAspect="1"/>
                      </p:cNvPicPr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505592" y="3868109"/>
                        <a:ext cx="1434559" cy="2151838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30" name="Straight Arrow Connector 29"/>
                      <p:cNvCxnSpPr/>
                      <p:nvPr/>
                    </p:nvCxnSpPr>
                    <p:spPr>
                      <a:xfrm>
                        <a:off x="7984216" y="5127199"/>
                        <a:ext cx="1117931" cy="379841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" name="Straight Arrow Connector 31"/>
                      <p:cNvCxnSpPr/>
                      <p:nvPr/>
                    </p:nvCxnSpPr>
                    <p:spPr>
                      <a:xfrm flipV="1">
                        <a:off x="8255469" y="4536063"/>
                        <a:ext cx="812894" cy="14730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4" name="TextBox 33"/>
                      <p:cNvSpPr txBox="1"/>
                      <p:nvPr/>
                    </p:nvSpPr>
                    <p:spPr>
                      <a:xfrm>
                        <a:off x="9132880" y="3696712"/>
                        <a:ext cx="53572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cion</a:t>
                        </a:r>
                        <a:endParaRPr lang="en-US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5" name="TextBox 34"/>
                      <p:cNvSpPr txBox="1"/>
                      <p:nvPr/>
                    </p:nvSpPr>
                    <p:spPr>
                      <a:xfrm>
                        <a:off x="9080112" y="4877916"/>
                        <a:ext cx="841897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ootstock</a:t>
                        </a:r>
                        <a:endParaRPr lang="en-US" sz="12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grpSp>
                    <p:nvGrpSpPr>
                      <p:cNvPr id="44" name="Group 43"/>
                      <p:cNvGrpSpPr/>
                      <p:nvPr/>
                    </p:nvGrpSpPr>
                    <p:grpSpPr>
                      <a:xfrm>
                        <a:off x="9063597" y="4134865"/>
                        <a:ext cx="173185" cy="690587"/>
                        <a:chOff x="9415553" y="4086243"/>
                        <a:chExt cx="173185" cy="690587"/>
                      </a:xfrm>
                    </p:grpSpPr>
                    <p:sp>
                      <p:nvSpPr>
                        <p:cNvPr id="42" name="Flowchart: Delay 41"/>
                        <p:cNvSpPr/>
                        <p:nvPr/>
                      </p:nvSpPr>
                      <p:spPr>
                        <a:xfrm rot="5400000" flipV="1">
                          <a:off x="9264669" y="4460381"/>
                          <a:ext cx="472099" cy="160799"/>
                        </a:xfrm>
                        <a:prstGeom prst="flowChartDelay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41" name="Flowchart: Sequential Access Storage 40"/>
                        <p:cNvSpPr/>
                        <p:nvPr/>
                      </p:nvSpPr>
                      <p:spPr>
                        <a:xfrm rot="12507589">
                          <a:off x="9447113" y="4581988"/>
                          <a:ext cx="99989" cy="105506"/>
                        </a:xfrm>
                        <a:prstGeom prst="flowChartMagneticTape">
                          <a:avLst/>
                        </a:prstGeom>
                        <a:gradFill flip="none" rotWithShape="1">
                          <a:gsLst>
                            <a:gs pos="0">
                              <a:srgbClr val="FF66CC">
                                <a:tint val="66000"/>
                                <a:satMod val="160000"/>
                              </a:srgbClr>
                            </a:gs>
                            <a:gs pos="50000">
                              <a:srgbClr val="FF66CC">
                                <a:tint val="44500"/>
                                <a:satMod val="160000"/>
                              </a:srgbClr>
                            </a:gs>
                            <a:gs pos="100000">
                              <a:srgbClr val="FF66CC">
                                <a:tint val="23500"/>
                                <a:satMod val="160000"/>
                              </a:srgbClr>
                            </a:gs>
                          </a:gsLst>
                          <a:lin ang="5400000" scaled="1"/>
                          <a:tileRect/>
                        </a:gradFill>
                        <a:ln>
                          <a:solidFill>
                            <a:srgbClr val="FF66CC">
                              <a:alpha val="14902"/>
                            </a:srgbClr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43" name="Flowchart: Direct Access Storage 42"/>
                        <p:cNvSpPr/>
                        <p:nvPr/>
                      </p:nvSpPr>
                      <p:spPr>
                        <a:xfrm rot="5400000">
                          <a:off x="9377145" y="4124651"/>
                          <a:ext cx="250002" cy="173185"/>
                        </a:xfrm>
                        <a:prstGeom prst="flowChartMagneticDrum">
                          <a:avLst/>
                        </a:prstGeom>
                        <a:solidFill>
                          <a:schemeClr val="accent5">
                            <a:lumMod val="75000"/>
                          </a:schemeClr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  <p:sp>
                    <p:nvSpPr>
                      <p:cNvPr id="49" name="TextBox 48"/>
                      <p:cNvSpPr txBox="1"/>
                      <p:nvPr/>
                    </p:nvSpPr>
                    <p:spPr>
                      <a:xfrm>
                        <a:off x="9202550" y="3311049"/>
                        <a:ext cx="1685077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sz="14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amples collection  </a:t>
                        </a:r>
                        <a:endPara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cxnSp>
                    <p:nvCxnSpPr>
                      <p:cNvPr id="51" name="Straight Connector 50"/>
                      <p:cNvCxnSpPr/>
                      <p:nvPr/>
                    </p:nvCxnSpPr>
                    <p:spPr>
                      <a:xfrm flipV="1">
                        <a:off x="7424260" y="6116644"/>
                        <a:ext cx="4767740" cy="6515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4" name="TextBox 53"/>
                      <p:cNvSpPr txBox="1"/>
                      <p:nvPr/>
                    </p:nvSpPr>
                    <p:spPr>
                      <a:xfrm>
                        <a:off x="9368696" y="3950566"/>
                        <a:ext cx="50206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tem</a:t>
                        </a:r>
                        <a:endPara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5" name="TextBox 54"/>
                      <p:cNvSpPr txBox="1"/>
                      <p:nvPr/>
                    </p:nvSpPr>
                    <p:spPr>
                      <a:xfrm>
                        <a:off x="8954326" y="5093413"/>
                        <a:ext cx="41549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ap</a:t>
                        </a:r>
                        <a:endPara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56" name="Rectangle 55"/>
                      <p:cNvSpPr/>
                      <p:nvPr/>
                    </p:nvSpPr>
                    <p:spPr>
                      <a:xfrm>
                        <a:off x="9906616" y="3547209"/>
                        <a:ext cx="2202847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Fully developed </a:t>
                        </a:r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youngest </a:t>
                        </a:r>
                        <a:r>
                          <a:rPr lang="en-US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leaves</a:t>
                        </a:r>
                      </a:p>
                    </p:txBody>
                  </p:sp>
                  <p:sp>
                    <p:nvSpPr>
                      <p:cNvPr id="57" name="Rectangle 56"/>
                      <p:cNvSpPr/>
                      <p:nvPr/>
                    </p:nvSpPr>
                    <p:spPr>
                      <a:xfrm>
                        <a:off x="10329835" y="5289565"/>
                        <a:ext cx="543739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oots</a:t>
                        </a:r>
                        <a:endPara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pic>
                    <p:nvPicPr>
                      <p:cNvPr id="63" name="Picture 62"/>
                      <p:cNvPicPr>
                        <a:picLocks noChangeAspect="1"/>
                      </p:cNvPicPr>
                      <p:nvPr/>
                    </p:nvPicPr>
                    <p:blipFill>
                      <a:blip r:embed="rId1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0374709" y="3782675"/>
                        <a:ext cx="1509255" cy="100617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6" name="TextBox 65"/>
                      <p:cNvSpPr txBox="1"/>
                      <p:nvPr/>
                    </p:nvSpPr>
                    <p:spPr>
                      <a:xfrm>
                        <a:off x="7361963" y="3396360"/>
                        <a:ext cx="29527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  <a:endPara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83" name="TextBox 82"/>
                      <p:cNvSpPr txBox="1"/>
                      <p:nvPr/>
                    </p:nvSpPr>
                    <p:spPr>
                      <a:xfrm>
                        <a:off x="9521595" y="5107414"/>
                        <a:ext cx="50206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tem</a:t>
                        </a:r>
                        <a:endPara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85" name="TextBox 84"/>
                      <p:cNvSpPr txBox="1"/>
                      <p:nvPr/>
                    </p:nvSpPr>
                    <p:spPr>
                      <a:xfrm>
                        <a:off x="8980450" y="3850341"/>
                        <a:ext cx="41549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ap</a:t>
                        </a:r>
                        <a:endPara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73" name="Group 72">
                    <a:extLst>
                      <a:ext uri="{FF2B5EF4-FFF2-40B4-BE49-F238E27FC236}">
                        <a16:creationId xmlns:a16="http://schemas.microsoft.com/office/drawing/2014/main" id="{D7A37508-1884-4394-8C42-2ECD8F0BAED4}"/>
                      </a:ext>
                    </a:extLst>
                  </p:cNvPr>
                  <p:cNvGrpSpPr/>
                  <p:nvPr/>
                </p:nvGrpSpPr>
                <p:grpSpPr>
                  <a:xfrm>
                    <a:off x="9316020" y="4073122"/>
                    <a:ext cx="505074" cy="835689"/>
                    <a:chOff x="1765300" y="1548012"/>
                    <a:chExt cx="1930400" cy="2794000"/>
                  </a:xfrm>
                </p:grpSpPr>
                <p:pic>
                  <p:nvPicPr>
                    <p:cNvPr id="74" name="Picture 73">
                      <a:extLst>
                        <a:ext uri="{FF2B5EF4-FFF2-40B4-BE49-F238E27FC236}">
                          <a16:creationId xmlns:a16="http://schemas.microsoft.com/office/drawing/2014/main" id="{E6234AD1-0C03-4025-B026-7D2DEB05214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 cstate="print">
                      <a:clrChange>
                        <a:clrFrom>
                          <a:srgbClr val="000000">
                            <a:alpha val="0"/>
                          </a:srgbClr>
                        </a:clrFrom>
                        <a:clrTo>
                          <a:srgbClr val="000000">
                            <a:alpha val="0"/>
                          </a:srgbClr>
                        </a:clrTo>
                      </a:clrChange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65300" y="1548012"/>
                      <a:ext cx="1598229" cy="2794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5" name="Picture 74">
                      <a:extLst>
                        <a:ext uri="{FF2B5EF4-FFF2-40B4-BE49-F238E27FC236}">
                          <a16:creationId xmlns:a16="http://schemas.microsoft.com/office/drawing/2014/main" id="{F1D3D178-40EF-4F1C-966F-C00BDC17508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5"/>
                    <a:srcRect r="-8225" b="61463"/>
                    <a:stretch/>
                  </p:blipFill>
                  <p:spPr>
                    <a:xfrm rot="10800000" flipH="1">
                      <a:off x="2564415" y="2474786"/>
                      <a:ext cx="1131285" cy="1551642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76" name="Group 75">
                    <a:extLst>
                      <a:ext uri="{FF2B5EF4-FFF2-40B4-BE49-F238E27FC236}">
                        <a16:creationId xmlns:a16="http://schemas.microsoft.com/office/drawing/2014/main" id="{F519E5CE-573C-403D-86F1-8CB27E6F4388}"/>
                      </a:ext>
                    </a:extLst>
                  </p:cNvPr>
                  <p:cNvGrpSpPr/>
                  <p:nvPr/>
                </p:nvGrpSpPr>
                <p:grpSpPr>
                  <a:xfrm>
                    <a:off x="9420243" y="5205579"/>
                    <a:ext cx="470494" cy="831624"/>
                    <a:chOff x="5408787" y="1890574"/>
                    <a:chExt cx="1485857" cy="2792210"/>
                  </a:xfrm>
                </p:grpSpPr>
                <p:pic>
                  <p:nvPicPr>
                    <p:cNvPr id="77" name="Picture 76">
                      <a:extLst>
                        <a:ext uri="{FF2B5EF4-FFF2-40B4-BE49-F238E27FC236}">
                          <a16:creationId xmlns:a16="http://schemas.microsoft.com/office/drawing/2014/main" id="{57357A65-AABC-4C4C-86D8-446E5D16157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6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7">
                              <a14:imgEffect>
                                <a14:backgroundRemoval t="42243" b="54916" l="13440" r="29386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1100" t="41416" r="69950" b="43449"/>
                    <a:stretch/>
                  </p:blipFill>
                  <p:spPr>
                    <a:xfrm rot="5400000">
                      <a:off x="5738549" y="3364249"/>
                      <a:ext cx="1688102" cy="62408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8" name="Picture 77">
                      <a:extLst>
                        <a:ext uri="{FF2B5EF4-FFF2-40B4-BE49-F238E27FC236}">
                          <a16:creationId xmlns:a16="http://schemas.microsoft.com/office/drawing/2014/main" id="{C9C0B5F2-DC4E-4B8F-94D1-BD33BCB3347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5408787" y="1890574"/>
                      <a:ext cx="1402241" cy="2792210"/>
                    </a:xfrm>
                    <a:prstGeom prst="rect">
                      <a:avLst/>
                    </a:prstGeom>
                  </p:spPr>
                </p:pic>
              </p:grpSp>
            </p:grpSp>
            <p:pic>
              <p:nvPicPr>
                <p:cNvPr id="87" name="Picture 8" descr="C:\Users\Administrator\Pictures\melon 1-24-17\1-24-2017.JPG">
                  <a:extLst>
                    <a:ext uri="{FF2B5EF4-FFF2-40B4-BE49-F238E27FC236}">
                      <a16:creationId xmlns:a16="http://schemas.microsoft.com/office/drawing/2014/main" id="{A5A9E9BE-A8D0-42A8-A800-9B1CB2B27B2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637" t="9188" r="41662" b="19294"/>
                <a:stretch/>
              </p:blipFill>
              <p:spPr bwMode="auto">
                <a:xfrm>
                  <a:off x="10688788" y="4853346"/>
                  <a:ext cx="999161" cy="124206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</p:grpSp>
      </p:grpSp>
      <p:sp>
        <p:nvSpPr>
          <p:cNvPr id="50" name="TextBox 49"/>
          <p:cNvSpPr txBox="1"/>
          <p:nvPr/>
        </p:nvSpPr>
        <p:spPr>
          <a:xfrm>
            <a:off x="263200" y="391826"/>
            <a:ext cx="2109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86983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82</TotalTime>
  <Words>21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Microsoft Excel Worksheet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Dolores Camalle</dc:creator>
  <cp:lastModifiedBy>Maria Dolores Camalle</cp:lastModifiedBy>
  <cp:revision>50</cp:revision>
  <dcterms:created xsi:type="dcterms:W3CDTF">2021-11-22T07:09:32Z</dcterms:created>
  <dcterms:modified xsi:type="dcterms:W3CDTF">2022-04-20T15:11:41Z</dcterms:modified>
</cp:coreProperties>
</file>